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75" d="100"/>
          <a:sy n="75" d="100"/>
        </p:scale>
        <p:origin x="240" y="-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35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315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144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11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11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319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170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25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926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699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110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1BA2E0-6B17-4DA3-8A5A-718EB58139BC}" type="datetimeFigureOut">
              <a:rPr lang="en-US" smtClean="0"/>
              <a:t>5/18/2025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0B7AA-ADDD-4720-A0A7-714A41CAF2D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80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uadroTexto 14">
            <a:extLst>
              <a:ext uri="{FF2B5EF4-FFF2-40B4-BE49-F238E27FC236}">
                <a16:creationId xmlns:a16="http://schemas.microsoft.com/office/drawing/2014/main" id="{5ED40DE6-8C1F-201B-19DB-9EA32A361368}"/>
              </a:ext>
            </a:extLst>
          </p:cNvPr>
          <p:cNvSpPr txBox="1"/>
          <p:nvPr/>
        </p:nvSpPr>
        <p:spPr>
          <a:xfrm>
            <a:off x="9897663" y="3222891"/>
            <a:ext cx="1025404" cy="24904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-) H</a:t>
            </a:r>
            <a:r>
              <a:rPr lang="es-MX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BA8ABAA-B86F-59E3-21CD-CD1358480166}"/>
              </a:ext>
            </a:extLst>
          </p:cNvPr>
          <p:cNvSpPr txBox="1"/>
          <p:nvPr/>
        </p:nvSpPr>
        <p:spPr>
          <a:xfrm>
            <a:off x="8326439" y="3241063"/>
            <a:ext cx="990850" cy="24904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-) PD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0925C87-8533-B586-2441-A46482153351}"/>
              </a:ext>
            </a:extLst>
          </p:cNvPr>
          <p:cNvSpPr txBox="1"/>
          <p:nvPr/>
        </p:nvSpPr>
        <p:spPr>
          <a:xfrm>
            <a:off x="9076690" y="1491921"/>
            <a:ext cx="111301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(+) </a:t>
            </a:r>
            <a:r>
              <a:rPr lang="es-MX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etalaxil</a:t>
            </a:r>
            <a:endParaRPr lang="es-MX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/>
          <p:cNvSpPr txBox="1"/>
          <p:nvPr/>
        </p:nvSpPr>
        <p:spPr>
          <a:xfrm>
            <a:off x="2104466" y="3268488"/>
            <a:ext cx="13177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102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EC88BAC-1F1C-3C0F-38CE-F206B9C4C8B3}"/>
              </a:ext>
            </a:extLst>
          </p:cNvPr>
          <p:cNvSpPr txBox="1"/>
          <p:nvPr/>
        </p:nvSpPr>
        <p:spPr>
          <a:xfrm>
            <a:off x="2239823" y="1569904"/>
            <a:ext cx="93677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70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1D1F90-E8DF-1CD9-C2AA-27C97535CBEB}"/>
              </a:ext>
            </a:extLst>
          </p:cNvPr>
          <p:cNvSpPr txBox="1"/>
          <p:nvPr/>
        </p:nvSpPr>
        <p:spPr>
          <a:xfrm>
            <a:off x="2047789" y="990341"/>
            <a:ext cx="14205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s-MX" sz="15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velezensis</a:t>
            </a:r>
            <a:endParaRPr 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AB56F41-1191-4D20-13AB-E1CF109AC653}"/>
              </a:ext>
            </a:extLst>
          </p:cNvPr>
          <p:cNvSpPr txBox="1"/>
          <p:nvPr/>
        </p:nvSpPr>
        <p:spPr>
          <a:xfrm>
            <a:off x="5144260" y="990341"/>
            <a:ext cx="1676137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s-MX" sz="15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egaterium</a:t>
            </a:r>
            <a:endParaRPr 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6BA26091-F073-95D2-FA27-AAC1BC5677A6}"/>
              </a:ext>
            </a:extLst>
          </p:cNvPr>
          <p:cNvSpPr txBox="1"/>
          <p:nvPr/>
        </p:nvSpPr>
        <p:spPr>
          <a:xfrm>
            <a:off x="8916683" y="990341"/>
            <a:ext cx="14205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C01D8B7B-47A4-AE2B-ECC1-3CE9155920F7}"/>
              </a:ext>
            </a:extLst>
          </p:cNvPr>
          <p:cNvSpPr txBox="1"/>
          <p:nvPr/>
        </p:nvSpPr>
        <p:spPr>
          <a:xfrm>
            <a:off x="4474365" y="1587543"/>
            <a:ext cx="9401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35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EE9CFD76-1689-D5D5-40BE-4537F6F9AB2E}"/>
              </a:ext>
            </a:extLst>
          </p:cNvPr>
          <p:cNvSpPr txBox="1"/>
          <p:nvPr/>
        </p:nvSpPr>
        <p:spPr>
          <a:xfrm>
            <a:off x="6426507" y="1596268"/>
            <a:ext cx="9401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113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033C2FD1-36ED-F7DE-B5F8-865BA0E6CC1C}"/>
              </a:ext>
            </a:extLst>
          </p:cNvPr>
          <p:cNvSpPr txBox="1"/>
          <p:nvPr/>
        </p:nvSpPr>
        <p:spPr>
          <a:xfrm>
            <a:off x="6397729" y="3280244"/>
            <a:ext cx="9401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127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73146D93-2C98-D25F-B6F8-45EF425D7AD0}"/>
              </a:ext>
            </a:extLst>
          </p:cNvPr>
          <p:cNvSpPr txBox="1"/>
          <p:nvPr/>
        </p:nvSpPr>
        <p:spPr>
          <a:xfrm>
            <a:off x="4474365" y="3261773"/>
            <a:ext cx="94013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200" b="1" dirty="0">
                <a:latin typeface="Arial" panose="020B0604020202020204" pitchFamily="34" charset="0"/>
                <a:cs typeface="Arial" panose="020B0604020202020204" pitchFamily="34" charset="0"/>
              </a:rPr>
              <a:t>ZAV-W64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DFF205B1-8BF5-F7A4-175D-4044963C92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59" t="23839" r="14085" b="25656"/>
          <a:stretch/>
        </p:blipFill>
        <p:spPr>
          <a:xfrm>
            <a:off x="1988211" y="1815676"/>
            <a:ext cx="1440000" cy="1406250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9221B7E1-9DB0-6D48-4AC9-CA346DAF268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79" t="21146" r="19473" b="31447"/>
          <a:stretch/>
        </p:blipFill>
        <p:spPr>
          <a:xfrm>
            <a:off x="8966554" y="1785284"/>
            <a:ext cx="1440000" cy="1427831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62BD2BDC-6912-57DE-54BA-82EEFC0582C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67" t="29091" r="18575" b="17711"/>
          <a:stretch/>
        </p:blipFill>
        <p:spPr>
          <a:xfrm>
            <a:off x="9794647" y="3481412"/>
            <a:ext cx="1440000" cy="1500792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953885F3-8CA0-0F3E-D14A-4514CDD0202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37" t="15623" r="23276" b="18115"/>
          <a:stretch/>
        </p:blipFill>
        <p:spPr>
          <a:xfrm>
            <a:off x="4224434" y="3498418"/>
            <a:ext cx="1440000" cy="1406325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DE6D1324-C3D5-7A18-171E-AACEB350B64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92" t="3097" r="10140" b="5993"/>
          <a:stretch/>
        </p:blipFill>
        <p:spPr>
          <a:xfrm>
            <a:off x="8130066" y="3499884"/>
            <a:ext cx="1440000" cy="150000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5D7A6DC8-3D90-210E-DE40-CAD43C468CA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97" t="9023" r="12379" b="9630"/>
          <a:stretch/>
        </p:blipFill>
        <p:spPr>
          <a:xfrm>
            <a:off x="4224434" y="1810885"/>
            <a:ext cx="1440000" cy="1437620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AB25366E-5E5C-4FD9-492F-64B5F965142C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7" t="12525" r="16950" b="11111"/>
          <a:stretch/>
        </p:blipFill>
        <p:spPr>
          <a:xfrm>
            <a:off x="2004116" y="3508543"/>
            <a:ext cx="1440000" cy="144766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582915A8-89E3-F315-E2F8-75D6E7C2AF7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91" t="7003" r="13203" b="7475"/>
          <a:stretch/>
        </p:blipFill>
        <p:spPr>
          <a:xfrm>
            <a:off x="6148418" y="1812370"/>
            <a:ext cx="1440000" cy="1460703"/>
          </a:xfrm>
          <a:prstGeom prst="rect">
            <a:avLst/>
          </a:prstGeom>
        </p:spPr>
      </p:pic>
      <p:pic>
        <p:nvPicPr>
          <p:cNvPr id="41" name="Imagen 40">
            <a:extLst>
              <a:ext uri="{FF2B5EF4-FFF2-40B4-BE49-F238E27FC236}">
                <a16:creationId xmlns:a16="http://schemas.microsoft.com/office/drawing/2014/main" id="{FBA5B2C2-6026-F589-5427-3335DCA43FA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7" t="19260" r="23963" b="28754"/>
          <a:stretch/>
        </p:blipFill>
        <p:spPr>
          <a:xfrm>
            <a:off x="6147798" y="3520300"/>
            <a:ext cx="1440000" cy="1486203"/>
          </a:xfrm>
          <a:prstGeom prst="rect">
            <a:avLst/>
          </a:prstGeom>
        </p:spPr>
      </p:pic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AA6FD6E7-6D03-1E4C-F5D7-605AB3C5076B}"/>
              </a:ext>
            </a:extLst>
          </p:cNvPr>
          <p:cNvCxnSpPr>
            <a:cxnSpLocks/>
          </p:cNvCxnSpPr>
          <p:nvPr/>
        </p:nvCxnSpPr>
        <p:spPr>
          <a:xfrm flipV="1">
            <a:off x="1988211" y="1381637"/>
            <a:ext cx="1480163" cy="7612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71F0B13E-9221-70FB-41E8-C0231EDEFDC6}"/>
              </a:ext>
            </a:extLst>
          </p:cNvPr>
          <p:cNvCxnSpPr>
            <a:cxnSpLocks/>
          </p:cNvCxnSpPr>
          <p:nvPr/>
        </p:nvCxnSpPr>
        <p:spPr>
          <a:xfrm>
            <a:off x="4226084" y="1381433"/>
            <a:ext cx="3361714" cy="802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3412650C-38B0-BB74-ADC2-AA9910E2B2EB}"/>
              </a:ext>
            </a:extLst>
          </p:cNvPr>
          <p:cNvCxnSpPr>
            <a:cxnSpLocks/>
          </p:cNvCxnSpPr>
          <p:nvPr/>
        </p:nvCxnSpPr>
        <p:spPr>
          <a:xfrm>
            <a:off x="8081782" y="1385443"/>
            <a:ext cx="315286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136D2573-AF96-6FFA-5828-ED871652FF38}"/>
              </a:ext>
            </a:extLst>
          </p:cNvPr>
          <p:cNvSpPr txBox="1"/>
          <p:nvPr/>
        </p:nvSpPr>
        <p:spPr>
          <a:xfrm>
            <a:off x="1249334" y="756424"/>
            <a:ext cx="990490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05378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upo 22">
            <a:extLst>
              <a:ext uri="{FF2B5EF4-FFF2-40B4-BE49-F238E27FC236}">
                <a16:creationId xmlns:a16="http://schemas.microsoft.com/office/drawing/2014/main" id="{144A7FCF-CD48-9163-00ED-AE08FDBAE89C}"/>
              </a:ext>
            </a:extLst>
          </p:cNvPr>
          <p:cNvGrpSpPr>
            <a:grpSpLocks noChangeAspect="1"/>
          </p:cNvGrpSpPr>
          <p:nvPr/>
        </p:nvGrpSpPr>
        <p:grpSpPr>
          <a:xfrm>
            <a:off x="8071089" y="1327797"/>
            <a:ext cx="2880000" cy="2969732"/>
            <a:chOff x="612940" y="2132438"/>
            <a:chExt cx="3956020" cy="4079278"/>
          </a:xfrm>
        </p:grpSpPr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3E9A12AB-6680-0A13-7029-C06817180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0" t="56225" r="3882"/>
            <a:stretch/>
          </p:blipFill>
          <p:spPr>
            <a:xfrm>
              <a:off x="616836" y="4951716"/>
              <a:ext cx="3948229" cy="1260000"/>
            </a:xfrm>
            <a:prstGeom prst="rect">
              <a:avLst/>
            </a:prstGeom>
          </p:spPr>
        </p:pic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5ED40DE6-8C1F-201B-19DB-9EA32A361368}"/>
                </a:ext>
              </a:extLst>
            </p:cNvPr>
            <p:cNvSpPr txBox="1"/>
            <p:nvPr/>
          </p:nvSpPr>
          <p:spPr>
            <a:xfrm>
              <a:off x="2035093" y="4958929"/>
              <a:ext cx="1149808" cy="3382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-) H</a:t>
              </a:r>
              <a:r>
                <a:rPr lang="es-MX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Imagen 20">
              <a:extLst>
                <a:ext uri="{FF2B5EF4-FFF2-40B4-BE49-F238E27FC236}">
                  <a16:creationId xmlns:a16="http://schemas.microsoft.com/office/drawing/2014/main" id="{A6C754D0-A417-13CE-EB91-378671B104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30" t="53894" r="13904" b="8572"/>
            <a:stretch/>
          </p:blipFill>
          <p:spPr>
            <a:xfrm>
              <a:off x="616836" y="3494915"/>
              <a:ext cx="3948229" cy="1421898"/>
            </a:xfrm>
            <a:prstGeom prst="rect">
              <a:avLst/>
            </a:prstGeom>
          </p:spPr>
        </p:pic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9BA8ABAA-B86F-59E3-21CD-CD1358480166}"/>
                </a:ext>
              </a:extLst>
            </p:cNvPr>
            <p:cNvSpPr txBox="1"/>
            <p:nvPr/>
          </p:nvSpPr>
          <p:spPr>
            <a:xfrm>
              <a:off x="2073838" y="3504659"/>
              <a:ext cx="1111061" cy="3382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-) PD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Imagen 21">
              <a:extLst>
                <a:ext uri="{FF2B5EF4-FFF2-40B4-BE49-F238E27FC236}">
                  <a16:creationId xmlns:a16="http://schemas.microsoft.com/office/drawing/2014/main" id="{0B6A223C-D966-70D4-6362-32059E9CE8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17" t="51429" r="11667" b="14523"/>
            <a:stretch/>
          </p:blipFill>
          <p:spPr>
            <a:xfrm>
              <a:off x="612940" y="2132438"/>
              <a:ext cx="3956020" cy="1323731"/>
            </a:xfrm>
            <a:prstGeom prst="rect">
              <a:avLst/>
            </a:prstGeom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70925C87-8533-B586-2441-A46482153351}"/>
                </a:ext>
              </a:extLst>
            </p:cNvPr>
            <p:cNvSpPr txBox="1"/>
            <p:nvPr/>
          </p:nvSpPr>
          <p:spPr>
            <a:xfrm>
              <a:off x="1879601" y="2144441"/>
              <a:ext cx="1539271" cy="33821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+) </a:t>
              </a:r>
              <a:r>
                <a:rPr lang="es-MX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etalaxil</a:t>
              </a:r>
              <a:endParaRPr lang="es-MX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upo 26">
            <a:extLst>
              <a:ext uri="{FF2B5EF4-FFF2-40B4-BE49-F238E27FC236}">
                <a16:creationId xmlns:a16="http://schemas.microsoft.com/office/drawing/2014/main" id="{1A38E0D2-2C5E-DA03-54A3-ABECFE9CA88F}"/>
              </a:ext>
            </a:extLst>
          </p:cNvPr>
          <p:cNvGrpSpPr>
            <a:grpSpLocks noChangeAspect="1"/>
          </p:cNvGrpSpPr>
          <p:nvPr/>
        </p:nvGrpSpPr>
        <p:grpSpPr>
          <a:xfrm>
            <a:off x="658078" y="1310550"/>
            <a:ext cx="2880000" cy="1998704"/>
            <a:chOff x="1039254" y="1403606"/>
            <a:chExt cx="3637130" cy="2524148"/>
          </a:xfrm>
        </p:grpSpPr>
        <p:pic>
          <p:nvPicPr>
            <p:cNvPr id="24" name="Imagen 23">
              <a:extLst>
                <a:ext uri="{FF2B5EF4-FFF2-40B4-BE49-F238E27FC236}">
                  <a16:creationId xmlns:a16="http://schemas.microsoft.com/office/drawing/2014/main" id="{F2BF0219-C4D6-1128-643C-51A79AC5BB1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9" t="49574" r="6401" b="7707"/>
            <a:stretch/>
          </p:blipFill>
          <p:spPr>
            <a:xfrm>
              <a:off x="1046570" y="2667754"/>
              <a:ext cx="3622498" cy="1260000"/>
            </a:xfrm>
            <a:prstGeom prst="rect">
              <a:avLst/>
            </a:prstGeom>
          </p:spPr>
        </p:pic>
        <p:sp>
          <p:nvSpPr>
            <p:cNvPr id="11" name="CuadroTexto 10"/>
            <p:cNvSpPr txBox="1"/>
            <p:nvPr/>
          </p:nvSpPr>
          <p:spPr>
            <a:xfrm>
              <a:off x="2387750" y="2674884"/>
              <a:ext cx="1133148" cy="3109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ZAV-W102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Imagen 25">
              <a:extLst>
                <a:ext uri="{FF2B5EF4-FFF2-40B4-BE49-F238E27FC236}">
                  <a16:creationId xmlns:a16="http://schemas.microsoft.com/office/drawing/2014/main" id="{CB7E49E6-D0CF-1565-4E0B-911A1CE5656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08" t="49219" r="4733" b="11623"/>
            <a:stretch/>
          </p:blipFill>
          <p:spPr>
            <a:xfrm>
              <a:off x="1039254" y="1403606"/>
              <a:ext cx="3637130" cy="1225544"/>
            </a:xfrm>
            <a:prstGeom prst="rect">
              <a:avLst/>
            </a:prstGeom>
          </p:spPr>
        </p:pic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7EC88BAC-1F1C-3C0F-38CE-F206B9C4C8B3}"/>
                </a:ext>
              </a:extLst>
            </p:cNvPr>
            <p:cNvSpPr txBox="1"/>
            <p:nvPr/>
          </p:nvSpPr>
          <p:spPr>
            <a:xfrm>
              <a:off x="2374943" y="1405001"/>
              <a:ext cx="965753" cy="31095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ZAV-W70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1D1F90-E8DF-1CD9-C2AA-27C97535CBEB}"/>
              </a:ext>
            </a:extLst>
          </p:cNvPr>
          <p:cNvSpPr txBox="1"/>
          <p:nvPr/>
        </p:nvSpPr>
        <p:spPr>
          <a:xfrm>
            <a:off x="1387785" y="749521"/>
            <a:ext cx="14205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i="1" dirty="0">
                <a:latin typeface="Arial" panose="020B0604020202020204" pitchFamily="34" charset="0"/>
                <a:cs typeface="Arial" panose="020B0604020202020204" pitchFamily="34" charset="0"/>
              </a:rPr>
              <a:t>B. velezensis</a:t>
            </a:r>
            <a:endParaRPr 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AB56F41-1191-4D20-13AB-E1CF109AC653}"/>
              </a:ext>
            </a:extLst>
          </p:cNvPr>
          <p:cNvSpPr txBox="1"/>
          <p:nvPr/>
        </p:nvSpPr>
        <p:spPr>
          <a:xfrm>
            <a:off x="5035936" y="749521"/>
            <a:ext cx="1676137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s-MX" sz="15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megaterium</a:t>
            </a:r>
            <a:endParaRPr lang="en-US" sz="15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6BA26091-F073-95D2-FA27-AAC1BC5677A6}"/>
              </a:ext>
            </a:extLst>
          </p:cNvPr>
          <p:cNvSpPr txBox="1"/>
          <p:nvPr/>
        </p:nvSpPr>
        <p:spPr>
          <a:xfrm>
            <a:off x="8814662" y="749521"/>
            <a:ext cx="1420585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endParaRPr 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Imagen 31">
            <a:extLst>
              <a:ext uri="{FF2B5EF4-FFF2-40B4-BE49-F238E27FC236}">
                <a16:creationId xmlns:a16="http://schemas.microsoft.com/office/drawing/2014/main" id="{7742B471-F19F-28C4-317E-094E19FEC27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3" t="55795" r="5939" b="3238"/>
          <a:stretch/>
        </p:blipFill>
        <p:spPr>
          <a:xfrm>
            <a:off x="4356011" y="1294909"/>
            <a:ext cx="2880000" cy="888818"/>
          </a:xfrm>
          <a:prstGeom prst="rect">
            <a:avLst/>
          </a:prstGeom>
        </p:spPr>
      </p:pic>
      <p:sp>
        <p:nvSpPr>
          <p:cNvPr id="33" name="CuadroTexto 32">
            <a:extLst>
              <a:ext uri="{FF2B5EF4-FFF2-40B4-BE49-F238E27FC236}">
                <a16:creationId xmlns:a16="http://schemas.microsoft.com/office/drawing/2014/main" id="{C01D8B7B-47A4-AE2B-ECC1-3CE9155920F7}"/>
              </a:ext>
            </a:extLst>
          </p:cNvPr>
          <p:cNvSpPr txBox="1"/>
          <p:nvPr/>
        </p:nvSpPr>
        <p:spPr>
          <a:xfrm>
            <a:off x="5359329" y="1305845"/>
            <a:ext cx="94013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ZAV-W35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Imagen 34">
            <a:extLst>
              <a:ext uri="{FF2B5EF4-FFF2-40B4-BE49-F238E27FC236}">
                <a16:creationId xmlns:a16="http://schemas.microsoft.com/office/drawing/2014/main" id="{BF59D976-62F4-C808-C477-2FABA9BFBD3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8" t="54294" r="4910" b="2671"/>
          <a:stretch/>
        </p:blipFill>
        <p:spPr>
          <a:xfrm>
            <a:off x="4341756" y="3308287"/>
            <a:ext cx="2880000" cy="962068"/>
          </a:xfrm>
          <a:prstGeom prst="rect">
            <a:avLst/>
          </a:prstGeom>
        </p:spPr>
      </p:pic>
      <p:sp>
        <p:nvSpPr>
          <p:cNvPr id="34" name="CuadroTexto 33">
            <a:extLst>
              <a:ext uri="{FF2B5EF4-FFF2-40B4-BE49-F238E27FC236}">
                <a16:creationId xmlns:a16="http://schemas.microsoft.com/office/drawing/2014/main" id="{EE9CFD76-1689-D5D5-40BE-4537F6F9AB2E}"/>
              </a:ext>
            </a:extLst>
          </p:cNvPr>
          <p:cNvSpPr txBox="1"/>
          <p:nvPr/>
        </p:nvSpPr>
        <p:spPr>
          <a:xfrm>
            <a:off x="5330159" y="3317523"/>
            <a:ext cx="94013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ZAV-W113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Imagen 35">
            <a:extLst>
              <a:ext uri="{FF2B5EF4-FFF2-40B4-BE49-F238E27FC236}">
                <a16:creationId xmlns:a16="http://schemas.microsoft.com/office/drawing/2014/main" id="{64CAEF90-8657-8164-5D7D-EEBD271238D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53" t="54987" r="7672" b="10909"/>
          <a:stretch/>
        </p:blipFill>
        <p:spPr>
          <a:xfrm>
            <a:off x="4360228" y="4384464"/>
            <a:ext cx="2880000" cy="949588"/>
          </a:xfrm>
          <a:prstGeom prst="rect">
            <a:avLst/>
          </a:prstGeom>
        </p:spPr>
      </p:pic>
      <p:sp>
        <p:nvSpPr>
          <p:cNvPr id="37" name="CuadroTexto 36">
            <a:extLst>
              <a:ext uri="{FF2B5EF4-FFF2-40B4-BE49-F238E27FC236}">
                <a16:creationId xmlns:a16="http://schemas.microsoft.com/office/drawing/2014/main" id="{033C2FD1-36ED-F7DE-B5F8-865BA0E6CC1C}"/>
              </a:ext>
            </a:extLst>
          </p:cNvPr>
          <p:cNvSpPr txBox="1"/>
          <p:nvPr/>
        </p:nvSpPr>
        <p:spPr>
          <a:xfrm>
            <a:off x="5311687" y="4384464"/>
            <a:ext cx="94013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ZAV-W127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Imagen 42">
            <a:extLst>
              <a:ext uri="{FF2B5EF4-FFF2-40B4-BE49-F238E27FC236}">
                <a16:creationId xmlns:a16="http://schemas.microsoft.com/office/drawing/2014/main" id="{17FD1F29-0D8D-9B41-2ACF-F1262DFC3BD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7" t="56431" r="3693" b="4378"/>
          <a:stretch/>
        </p:blipFill>
        <p:spPr>
          <a:xfrm>
            <a:off x="4343609" y="2297836"/>
            <a:ext cx="2880000" cy="896342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01D92371-03FA-ECBD-B01D-D3EA134A258F}"/>
              </a:ext>
            </a:extLst>
          </p:cNvPr>
          <p:cNvSpPr txBox="1"/>
          <p:nvPr/>
        </p:nvSpPr>
        <p:spPr>
          <a:xfrm>
            <a:off x="5322776" y="2305663"/>
            <a:ext cx="94013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000" b="1" dirty="0">
                <a:latin typeface="Arial" panose="020B0604020202020204" pitchFamily="34" charset="0"/>
                <a:cs typeface="Arial" panose="020B0604020202020204" pitchFamily="34" charset="0"/>
              </a:rPr>
              <a:t>ZAV-W64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Conector recto 2">
            <a:extLst>
              <a:ext uri="{FF2B5EF4-FFF2-40B4-BE49-F238E27FC236}">
                <a16:creationId xmlns:a16="http://schemas.microsoft.com/office/drawing/2014/main" id="{720A3998-EDD9-303F-6FB6-C6F0DA8AAB16}"/>
              </a:ext>
            </a:extLst>
          </p:cNvPr>
          <p:cNvCxnSpPr>
            <a:cxnSpLocks/>
          </p:cNvCxnSpPr>
          <p:nvPr/>
        </p:nvCxnSpPr>
        <p:spPr>
          <a:xfrm flipV="1">
            <a:off x="658078" y="1153031"/>
            <a:ext cx="2810296" cy="7816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Conector recto 3">
            <a:extLst>
              <a:ext uri="{FF2B5EF4-FFF2-40B4-BE49-F238E27FC236}">
                <a16:creationId xmlns:a16="http://schemas.microsoft.com/office/drawing/2014/main" id="{F631BA37-9E93-654F-5B8C-4E80E7EBA817}"/>
              </a:ext>
            </a:extLst>
          </p:cNvPr>
          <p:cNvCxnSpPr>
            <a:cxnSpLocks/>
          </p:cNvCxnSpPr>
          <p:nvPr/>
        </p:nvCxnSpPr>
        <p:spPr>
          <a:xfrm>
            <a:off x="4356011" y="1153031"/>
            <a:ext cx="2880000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76228811-BF8B-5F49-858C-CCB33248DADF}"/>
              </a:ext>
            </a:extLst>
          </p:cNvPr>
          <p:cNvCxnSpPr>
            <a:cxnSpLocks/>
          </p:cNvCxnSpPr>
          <p:nvPr/>
        </p:nvCxnSpPr>
        <p:spPr>
          <a:xfrm>
            <a:off x="8081782" y="1156837"/>
            <a:ext cx="2866471" cy="401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8AC50C46-7E8C-6ED0-2011-6782F017E48C}"/>
              </a:ext>
            </a:extLst>
          </p:cNvPr>
          <p:cNvSpPr txBox="1"/>
          <p:nvPr/>
        </p:nvSpPr>
        <p:spPr>
          <a:xfrm>
            <a:off x="0" y="441091"/>
            <a:ext cx="990490" cy="3231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MX" sz="15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2D7A245-AD60-4822-608A-D67996835CC8}"/>
              </a:ext>
            </a:extLst>
          </p:cNvPr>
          <p:cNvSpPr txBox="1"/>
          <p:nvPr/>
        </p:nvSpPr>
        <p:spPr>
          <a:xfrm>
            <a:off x="431516" y="5448161"/>
            <a:ext cx="11379483" cy="1021883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S4: </a:t>
            </a:r>
            <a:r>
              <a:rPr lang="en-US" sz="1400" b="1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valuation of bacterial supernatant antifungal activity in wheat seeds. </a:t>
            </a:r>
            <a:r>
              <a:rPr lang="en-US" sz="140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) </a:t>
            </a:r>
            <a:r>
              <a:rPr lang="en-US" sz="1400" b="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op-view of representative glass flasks containing wheat seeds treated with: (</a:t>
            </a:r>
            <a:r>
              <a:rPr lang="en-US" sz="1400" b="0" i="0" dirty="0" err="1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400" b="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bacterial supernatants of </a:t>
            </a:r>
            <a:r>
              <a:rPr lang="en-US" sz="1400" b="0" i="1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400" b="0" i="1" dirty="0" err="1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elezensis</a:t>
            </a:r>
            <a:r>
              <a:rPr lang="en-US" sz="1400" b="0" i="1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b="0" i="1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. megaterium </a:t>
            </a:r>
            <a:r>
              <a:rPr lang="en-US" sz="1400" b="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rains, (ii) negative controls (sterile water or PD broth), or (iii) positive control (</a:t>
            </a:r>
            <a:r>
              <a:rPr lang="en-US" sz="1400" b="0" i="0" dirty="0" err="1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etalaxyl</a:t>
            </a:r>
            <a:r>
              <a:rPr lang="en-US" sz="1400" b="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® 10 µg/mL). </a:t>
            </a:r>
            <a:r>
              <a:rPr lang="en-US" sz="1400" b="1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400" b="0" i="0" dirty="0">
                <a:solidFill>
                  <a:srgbClr val="40404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 Side-view of triplicate flasks per treatment, demonstrating experimental reproducibility.</a:t>
            </a:r>
            <a:endParaRPr lang="es-AR" sz="14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89403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4</TotalTime>
  <Words>123</Words>
  <Application>Microsoft Office PowerPoint</Application>
  <PresentationFormat>Panorámica</PresentationFormat>
  <Paragraphs>27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ime</dc:creator>
  <cp:lastModifiedBy>Martin Espariz</cp:lastModifiedBy>
  <cp:revision>19</cp:revision>
  <dcterms:created xsi:type="dcterms:W3CDTF">2021-12-12T19:41:31Z</dcterms:created>
  <dcterms:modified xsi:type="dcterms:W3CDTF">2025-05-18T20:15:45Z</dcterms:modified>
</cp:coreProperties>
</file>